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864" r:id="rId2"/>
  </p:sldIdLst>
  <p:sldSz cx="7315200" cy="9321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4CFF"/>
    <a:srgbClr val="00B5FF"/>
    <a:srgbClr val="A20305"/>
    <a:srgbClr val="A303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857"/>
    <p:restoredTop sz="95551"/>
  </p:normalViewPr>
  <p:slideViewPr>
    <p:cSldViewPr snapToGrid="0" snapToObjects="1">
      <p:cViewPr varScale="1">
        <p:scale>
          <a:sx n="80" d="100"/>
          <a:sy n="80" d="100"/>
        </p:scale>
        <p:origin x="260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F5A565-0660-F24A-9241-43E2B99AF08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143000"/>
            <a:ext cx="242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1F7975-6509-8042-909C-D5380521D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10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25583"/>
            <a:ext cx="6217920" cy="32453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96103"/>
            <a:ext cx="5486400" cy="2250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74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32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96299"/>
            <a:ext cx="1577340" cy="789979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96299"/>
            <a:ext cx="4640580" cy="789979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22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493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23979"/>
            <a:ext cx="6309360" cy="387760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238272"/>
            <a:ext cx="6309360" cy="2039143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2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69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96301"/>
            <a:ext cx="6309360" cy="1801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85136"/>
            <a:ext cx="3094672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405047"/>
            <a:ext cx="3094672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85136"/>
            <a:ext cx="3109913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405047"/>
            <a:ext cx="3109913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47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59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42169"/>
            <a:ext cx="3703320" cy="662452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42169"/>
            <a:ext cx="3703320" cy="662452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7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96301"/>
            <a:ext cx="6309360" cy="1801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81498"/>
            <a:ext cx="6309360" cy="59145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639929"/>
            <a:ext cx="246888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51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80CDF0-45AA-6C4D-BFF6-E4B1D174525E}"/>
              </a:ext>
            </a:extLst>
          </p:cNvPr>
          <p:cNvSpPr txBox="1">
            <a:spLocks/>
          </p:cNvSpPr>
          <p:nvPr/>
        </p:nvSpPr>
        <p:spPr>
          <a:xfrm>
            <a:off x="0" y="49936"/>
            <a:ext cx="7692571" cy="376845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50C36C2-F2D0-2942-B72A-16F7C7984D69}"/>
              </a:ext>
            </a:extLst>
          </p:cNvPr>
          <p:cNvSpPr txBox="1"/>
          <p:nvPr/>
        </p:nvSpPr>
        <p:spPr>
          <a:xfrm>
            <a:off x="5590960" y="2880120"/>
            <a:ext cx="87326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b="1" i="1" u="sng" dirty="0"/>
              <a:t>CTLA4</a:t>
            </a:r>
            <a:endParaRPr lang="en-US" b="1" i="1" u="sng" dirty="0">
              <a:ea typeface="Calibri"/>
              <a:cs typeface="Calibri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512890C-2583-DB45-AD96-99D8DC6DC24C}"/>
              </a:ext>
            </a:extLst>
          </p:cNvPr>
          <p:cNvSpPr txBox="1"/>
          <p:nvPr/>
        </p:nvSpPr>
        <p:spPr>
          <a:xfrm>
            <a:off x="967758" y="5176200"/>
            <a:ext cx="87326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b="1" i="1" u="sng" dirty="0">
                <a:ea typeface="Calibri"/>
                <a:cs typeface="Calibri"/>
              </a:rPr>
              <a:t>PD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4EE874C-0481-8442-82D1-0781DCDED4E6}"/>
              </a:ext>
            </a:extLst>
          </p:cNvPr>
          <p:cNvSpPr txBox="1"/>
          <p:nvPr/>
        </p:nvSpPr>
        <p:spPr>
          <a:xfrm>
            <a:off x="3295328" y="5181429"/>
            <a:ext cx="87326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b="1" i="1" u="sng" dirty="0"/>
              <a:t>4-1BB</a:t>
            </a:r>
            <a:endParaRPr lang="en-US" b="1" i="1" u="sng" dirty="0">
              <a:ea typeface="Calibri"/>
              <a:cs typeface="Calibri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AC3DD45-69D9-1F44-B4EE-0D078771D93E}"/>
              </a:ext>
            </a:extLst>
          </p:cNvPr>
          <p:cNvSpPr txBox="1"/>
          <p:nvPr/>
        </p:nvSpPr>
        <p:spPr>
          <a:xfrm>
            <a:off x="3023596" y="2882351"/>
            <a:ext cx="144950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b="1" i="1" u="sng" dirty="0"/>
              <a:t>Ki67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348D789-2025-EA45-AFB7-9A17FCE34E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3606" y="3251311"/>
            <a:ext cx="2331720" cy="169662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60A568D-B6DC-4940-B3D4-7CB875F0E1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82807" y="3344074"/>
            <a:ext cx="2331720" cy="169662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798E4E3-5F06-3B47-AEA7-D1EAF36D1A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3646" y="5715284"/>
            <a:ext cx="2331720" cy="169662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9D1AE24-1107-3B46-AB59-00FB0C89372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66100" y="5713793"/>
            <a:ext cx="2331720" cy="1758192"/>
          </a:xfrm>
          <a:prstGeom prst="rect">
            <a:avLst/>
          </a:prstGeom>
        </p:spPr>
      </p:pic>
      <p:sp>
        <p:nvSpPr>
          <p:cNvPr id="12" name="TextBox 37">
            <a:extLst>
              <a:ext uri="{FF2B5EF4-FFF2-40B4-BE49-F238E27FC236}">
                <a16:creationId xmlns:a16="http://schemas.microsoft.com/office/drawing/2014/main" id="{0459EA54-A6FC-B84A-AC1D-256AF1976010}"/>
              </a:ext>
            </a:extLst>
          </p:cNvPr>
          <p:cNvSpPr txBox="1"/>
          <p:nvPr/>
        </p:nvSpPr>
        <p:spPr>
          <a:xfrm>
            <a:off x="5447336" y="428312"/>
            <a:ext cx="99993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i="1" u="sng" dirty="0"/>
              <a:t>TIM-3</a:t>
            </a:r>
            <a:endParaRPr lang="en-US" sz="1600" b="1" i="1" u="sng" dirty="0">
              <a:ea typeface="Calibri"/>
              <a:cs typeface="Calibri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73B6CEA8-C3DC-8547-8360-D854EB8D74D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87608" y="855661"/>
            <a:ext cx="2331720" cy="1758192"/>
          </a:xfrm>
          <a:prstGeom prst="rect">
            <a:avLst/>
          </a:prstGeom>
        </p:spPr>
      </p:pic>
      <p:sp>
        <p:nvSpPr>
          <p:cNvPr id="14" name="TextBox 39">
            <a:extLst>
              <a:ext uri="{FF2B5EF4-FFF2-40B4-BE49-F238E27FC236}">
                <a16:creationId xmlns:a16="http://schemas.microsoft.com/office/drawing/2014/main" id="{401BE4B2-5A16-AD40-A4C6-C537F93D9B95}"/>
              </a:ext>
            </a:extLst>
          </p:cNvPr>
          <p:cNvSpPr txBox="1"/>
          <p:nvPr/>
        </p:nvSpPr>
        <p:spPr>
          <a:xfrm>
            <a:off x="3120156" y="431071"/>
            <a:ext cx="142018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i="1" u="sng" dirty="0"/>
              <a:t>KLRG1+</a:t>
            </a:r>
            <a:endParaRPr lang="en-US" b="1" i="1" u="sng" dirty="0">
              <a:ea typeface="Calibri"/>
              <a:cs typeface="Calibri"/>
            </a:endParaRPr>
          </a:p>
        </p:txBody>
      </p:sp>
      <p:sp>
        <p:nvSpPr>
          <p:cNvPr id="15" name="TextBox 40">
            <a:extLst>
              <a:ext uri="{FF2B5EF4-FFF2-40B4-BE49-F238E27FC236}">
                <a16:creationId xmlns:a16="http://schemas.microsoft.com/office/drawing/2014/main" id="{2C2A2514-2F4A-1544-BC81-1090ABAE0C06}"/>
              </a:ext>
            </a:extLst>
          </p:cNvPr>
          <p:cNvSpPr txBox="1"/>
          <p:nvPr/>
        </p:nvSpPr>
        <p:spPr>
          <a:xfrm>
            <a:off x="639118" y="426781"/>
            <a:ext cx="181110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i="1" u="sng" dirty="0"/>
              <a:t>CD103+ KLRG1+</a:t>
            </a:r>
            <a:endParaRPr lang="en-US" b="1" i="1" u="sng" dirty="0">
              <a:ea typeface="Calibri"/>
              <a:cs typeface="Calibri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4652CC53-EA89-394E-A812-1C40A232D66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4652" y="855661"/>
            <a:ext cx="2331720" cy="169662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73A5D78-80CF-A740-AD84-8E4F3EF4007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50226" y="887938"/>
            <a:ext cx="2331720" cy="1696621"/>
          </a:xfrm>
          <a:prstGeom prst="rect">
            <a:avLst/>
          </a:prstGeom>
        </p:spPr>
      </p:pic>
      <p:sp>
        <p:nvSpPr>
          <p:cNvPr id="18" name="TextBox 28">
            <a:extLst>
              <a:ext uri="{FF2B5EF4-FFF2-40B4-BE49-F238E27FC236}">
                <a16:creationId xmlns:a16="http://schemas.microsoft.com/office/drawing/2014/main" id="{5804C166-ED22-8F43-B4A2-9E71A479C060}"/>
              </a:ext>
            </a:extLst>
          </p:cNvPr>
          <p:cNvSpPr txBox="1"/>
          <p:nvPr/>
        </p:nvSpPr>
        <p:spPr>
          <a:xfrm>
            <a:off x="680623" y="2880120"/>
            <a:ext cx="181110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i="1" u="sng" dirty="0"/>
              <a:t>TIGIT</a:t>
            </a:r>
            <a:endParaRPr lang="en-US" b="1" i="1" u="sng" dirty="0">
              <a:ea typeface="Calibri"/>
              <a:cs typeface="Calibri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F33692AF-19E8-7D41-AB60-0E0831B77CE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5244" y="3246547"/>
            <a:ext cx="2331720" cy="1696621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06C06D3-E3B1-9B4C-ACF0-5DC8FCA35462}"/>
              </a:ext>
            </a:extLst>
          </p:cNvPr>
          <p:cNvSpPr txBox="1"/>
          <p:nvPr/>
        </p:nvSpPr>
        <p:spPr>
          <a:xfrm>
            <a:off x="11576" y="454052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A.</a:t>
            </a:r>
            <a:endParaRPr lang="en-US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EB75BC5-D2C4-2843-BC8E-13EB6486DE63}"/>
              </a:ext>
            </a:extLst>
          </p:cNvPr>
          <p:cNvSpPr txBox="1"/>
          <p:nvPr/>
        </p:nvSpPr>
        <p:spPr>
          <a:xfrm>
            <a:off x="2662488" y="431758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B.</a:t>
            </a:r>
            <a:endParaRPr lang="en-US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30BC10B-9AB3-404B-8009-C4E6BFD9B81A}"/>
              </a:ext>
            </a:extLst>
          </p:cNvPr>
          <p:cNvSpPr txBox="1"/>
          <p:nvPr/>
        </p:nvSpPr>
        <p:spPr>
          <a:xfrm>
            <a:off x="4893564" y="431758"/>
            <a:ext cx="4256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C.</a:t>
            </a:r>
            <a:endParaRPr lang="en-US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95729AB-DB14-7A45-B796-5FAE4C6BC55B}"/>
              </a:ext>
            </a:extLst>
          </p:cNvPr>
          <p:cNvSpPr txBox="1"/>
          <p:nvPr/>
        </p:nvSpPr>
        <p:spPr>
          <a:xfrm>
            <a:off x="95591" y="2916151"/>
            <a:ext cx="49405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D.</a:t>
            </a:r>
            <a:endParaRPr lang="en-US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71F66C0-69C8-C74C-BB4B-08A5C53345D2}"/>
              </a:ext>
            </a:extLst>
          </p:cNvPr>
          <p:cNvSpPr txBox="1"/>
          <p:nvPr/>
        </p:nvSpPr>
        <p:spPr>
          <a:xfrm>
            <a:off x="2627579" y="2882678"/>
            <a:ext cx="49405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E.</a:t>
            </a:r>
            <a:endParaRPr lang="en-US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EC51078-BF74-B64E-ACE7-5C58C058A340}"/>
              </a:ext>
            </a:extLst>
          </p:cNvPr>
          <p:cNvSpPr txBox="1"/>
          <p:nvPr/>
        </p:nvSpPr>
        <p:spPr>
          <a:xfrm>
            <a:off x="4780530" y="2882678"/>
            <a:ext cx="49405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F.</a:t>
            </a:r>
            <a:endParaRPr lang="en-US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243BF87-A2E4-D74E-A028-3694AADC773C}"/>
              </a:ext>
            </a:extLst>
          </p:cNvPr>
          <p:cNvSpPr txBox="1"/>
          <p:nvPr/>
        </p:nvSpPr>
        <p:spPr>
          <a:xfrm>
            <a:off x="74407" y="5144560"/>
            <a:ext cx="49405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G.</a:t>
            </a:r>
            <a:endParaRPr lang="en-US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F7A68DA-C7A0-EB42-B9DF-8D06A90EC956}"/>
              </a:ext>
            </a:extLst>
          </p:cNvPr>
          <p:cNvSpPr txBox="1"/>
          <p:nvPr/>
        </p:nvSpPr>
        <p:spPr>
          <a:xfrm>
            <a:off x="2626102" y="5141432"/>
            <a:ext cx="49405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>
                <a:ea typeface="Calibri"/>
                <a:cs typeface="Calibri"/>
              </a:rPr>
              <a:t>H.</a:t>
            </a:r>
            <a:endParaRPr lang="en-US" b="1" dirty="0"/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62DDA23F-3A41-3345-8CC3-D8CE7EB5900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74439" t="16935" r="1833" b="55527"/>
          <a:stretch/>
        </p:blipFill>
        <p:spPr>
          <a:xfrm>
            <a:off x="4780530" y="5750014"/>
            <a:ext cx="1090864" cy="737937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C214DAE5-5B3E-0F45-8FA4-9133D2ADF2E1}"/>
              </a:ext>
            </a:extLst>
          </p:cNvPr>
          <p:cNvSpPr txBox="1"/>
          <p:nvPr/>
        </p:nvSpPr>
        <p:spPr>
          <a:xfrm>
            <a:off x="-2792" y="7641370"/>
            <a:ext cx="727512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upplementary Figure S5: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ctivation and exhaustion markers on CD4</a:t>
            </a:r>
            <a:r>
              <a:rPr lang="en-US" sz="1200" b="1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subsets present in responders and non-responders.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nail</a:t>
            </a:r>
            <a:r>
              <a:rPr lang="en-US" sz="12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I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qM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and sgCD73 tumors that were untreated or treated with anti-CTLA4 were analyzed by flow cytometry for the indicated immune cell populations after gating on CD45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cells followed by CD3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 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T-cells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CD103 and KLRG1, % of CD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CD103 and KLRG1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KLRG1, % of CD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KLRG1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IM-3, % of CD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Tim3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IGIT, % of CD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TIGIT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Ki67, % of CD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Ki67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F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CTLA4, % of CD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CTLA4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G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PD1, % of CD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PD1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4-1BB, % of CD4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4-1BB. Bar graph data represent SEM, One-way ANOVA with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idak’s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multiple comparison test. All comparisons are not significant.</a:t>
            </a:r>
            <a:endParaRPr lang="en-US" sz="1200" dirty="0">
              <a:effectLst/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4495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22</TotalTime>
  <Words>213</Words>
  <Application>Microsoft Macintosh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ject #2</dc:title>
  <dc:creator>Microsoft Office User</dc:creator>
  <cp:lastModifiedBy>Anushka Dongre</cp:lastModifiedBy>
  <cp:revision>418</cp:revision>
  <dcterms:created xsi:type="dcterms:W3CDTF">2023-02-11T23:37:55Z</dcterms:created>
  <dcterms:modified xsi:type="dcterms:W3CDTF">2026-05-11T01:28:19Z</dcterms:modified>
</cp:coreProperties>
</file>